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83" r:id="rId2"/>
    <p:sldId id="282" r:id="rId3"/>
    <p:sldId id="277" r:id="rId4"/>
    <p:sldId id="27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0D54"/>
    <a:srgbClr val="8A30E3"/>
    <a:srgbClr val="CCCC99"/>
    <a:srgbClr val="65CC66"/>
    <a:srgbClr val="32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690"/>
    <p:restoredTop sz="94674"/>
  </p:normalViewPr>
  <p:slideViewPr>
    <p:cSldViewPr snapToGrid="0" snapToObjects="1">
      <p:cViewPr>
        <p:scale>
          <a:sx n="191" d="100"/>
          <a:sy n="191" d="100"/>
        </p:scale>
        <p:origin x="9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K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60A003-75FA-5F4C-846C-8202406A8A37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K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B6E399-F2A4-5649-AFC3-EE40D0627FF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894403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225116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316488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6422986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F87B86-6E55-584D-A306-8C46852C5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K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DE0AAE-6388-414A-9C1F-9CB56B166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B92ADF-A348-5E49-BFAD-2498CAC6B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4B8413-5CF1-9045-8415-43EC62916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540098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538928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251970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066677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4264471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503299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487007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69294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906920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99A2C-16F6-5F41-BCA6-1A5F6D2FFDFD}" type="datetimeFigureOut">
              <a:rPr lang="en-KR" smtClean="0"/>
              <a:t>2022/01/31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40F30-3F18-1A48-BC0D-47CC4252DA94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67524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image" Target="../media/image13.png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10" Type="http://schemas.openxmlformats.org/officeDocument/2006/relationships/image" Target="../media/image21.png"/><Relationship Id="rId19" Type="http://schemas.openxmlformats.org/officeDocument/2006/relationships/image" Target="../media/image30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>
            <a:extLst>
              <a:ext uri="{FF2B5EF4-FFF2-40B4-BE49-F238E27FC236}">
                <a16:creationId xmlns:a16="http://schemas.microsoft.com/office/drawing/2014/main" id="{20C508CE-AC4F-8545-A65A-B8E5D4C6E0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87"/>
          <a:stretch/>
        </p:blipFill>
        <p:spPr>
          <a:xfrm>
            <a:off x="4330464" y="5534529"/>
            <a:ext cx="1315936" cy="2177334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D8AFE3E1-682E-8040-9836-A931E94C987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78"/>
          <a:stretch/>
        </p:blipFill>
        <p:spPr>
          <a:xfrm>
            <a:off x="3001993" y="5544973"/>
            <a:ext cx="1311219" cy="216689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4C173BB8-B726-1343-A751-C28529E8DA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1740" y="5544973"/>
            <a:ext cx="1453322" cy="216689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B9A6E9B-B292-2147-B4C8-0652F60A90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58144" y="3335660"/>
            <a:ext cx="2138767" cy="1846031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F8134B4F-CAE4-8849-8611-441E5C1E60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61938" y="1156183"/>
            <a:ext cx="2140875" cy="184785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E32D3AD7-3B71-2944-86FB-B66DC89340A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5929" y="1162529"/>
            <a:ext cx="2138768" cy="1846031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0FA59C0D-2954-0A47-BEBD-CCB9EFBD5B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9500" y="3342403"/>
            <a:ext cx="2140875" cy="18478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DD5E91B-3CFD-3142-9FC0-9F9A30CA92BA}"/>
              </a:ext>
            </a:extLst>
          </p:cNvPr>
          <p:cNvSpPr txBox="1"/>
          <p:nvPr/>
        </p:nvSpPr>
        <p:spPr>
          <a:xfrm>
            <a:off x="112889" y="879184"/>
            <a:ext cx="1604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200" dirty="0">
                <a:latin typeface="Arial" panose="020B0604020202020204" pitchFamily="34" charset="0"/>
                <a:cs typeface="Arial" panose="020B0604020202020204" pitchFamily="34" charset="0"/>
              </a:rPr>
              <a:t>Lung cancer (n = 3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FE89A6A-9A7B-1A4B-9867-ADBBED02E398}"/>
              </a:ext>
            </a:extLst>
          </p:cNvPr>
          <p:cNvSpPr txBox="1"/>
          <p:nvPr/>
        </p:nvSpPr>
        <p:spPr>
          <a:xfrm>
            <a:off x="112889" y="3058661"/>
            <a:ext cx="16642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200" dirty="0">
                <a:latin typeface="Arial" panose="020B0604020202020204" pitchFamily="34" charset="0"/>
                <a:cs typeface="Arial" panose="020B0604020202020204" pitchFamily="34" charset="0"/>
              </a:rPr>
              <a:t>Colon cancer (n = 74)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09D39DAE-34C8-0B48-BDED-B321EA0DC70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11675" y="1156183"/>
            <a:ext cx="2165350" cy="184785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EA1D5FA-52A0-0345-ACEC-223444E6D6A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1675" y="3342006"/>
            <a:ext cx="2165350" cy="184785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6B359320-5F98-E444-A7C2-2101D6FB8B57}"/>
              </a:ext>
            </a:extLst>
          </p:cNvPr>
          <p:cNvSpPr txBox="1"/>
          <p:nvPr/>
        </p:nvSpPr>
        <p:spPr>
          <a:xfrm>
            <a:off x="82169" y="655636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aphicFrame>
        <p:nvGraphicFramePr>
          <p:cNvPr id="48" name="Table 3">
            <a:extLst>
              <a:ext uri="{FF2B5EF4-FFF2-40B4-BE49-F238E27FC236}">
                <a16:creationId xmlns:a16="http://schemas.microsoft.com/office/drawing/2014/main" id="{A8166293-6E75-0C49-B096-8C90A8FF16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6692"/>
              </p:ext>
            </p:extLst>
          </p:nvPr>
        </p:nvGraphicFramePr>
        <p:xfrm>
          <a:off x="772426" y="7779327"/>
          <a:ext cx="2016000" cy="6604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000">
                  <a:extLst>
                    <a:ext uri="{9D8B030D-6E8A-4147-A177-3AD203B41FA5}">
                      <a16:colId xmlns:a16="http://schemas.microsoft.com/office/drawing/2014/main" val="592160065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662194606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56224758"/>
                    </a:ext>
                  </a:extLst>
                </a:gridCol>
              </a:tblGrid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(ng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6442337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(ng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9666165"/>
                  </a:ext>
                </a:extLst>
              </a:tr>
              <a:tr h="23371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(wilcoxon)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KR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6997690"/>
                  </a:ext>
                </a:extLst>
              </a:tr>
            </a:tbl>
          </a:graphicData>
        </a:graphic>
      </p:graphicFrame>
      <p:graphicFrame>
        <p:nvGraphicFramePr>
          <p:cNvPr id="49" name="Table 3">
            <a:extLst>
              <a:ext uri="{FF2B5EF4-FFF2-40B4-BE49-F238E27FC236}">
                <a16:creationId xmlns:a16="http://schemas.microsoft.com/office/drawing/2014/main" id="{B03E555B-9732-FC4C-88F2-D75A33DBC4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0883425"/>
              </p:ext>
            </p:extLst>
          </p:nvPr>
        </p:nvGraphicFramePr>
        <p:xfrm>
          <a:off x="3209183" y="7784601"/>
          <a:ext cx="1008000" cy="640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04000">
                  <a:extLst>
                    <a:ext uri="{9D8B030D-6E8A-4147-A177-3AD203B41FA5}">
                      <a16:colId xmlns:a16="http://schemas.microsoft.com/office/drawing/2014/main" val="662194606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56224758"/>
                    </a:ext>
                  </a:extLst>
                </a:gridCol>
              </a:tblGrid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4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6442337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83699311"/>
                  </a:ext>
                </a:extLst>
              </a:tr>
              <a:tr h="124682">
                <a:tc gridSpan="2"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9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KR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6997690"/>
                  </a:ext>
                </a:extLst>
              </a:tr>
            </a:tbl>
          </a:graphicData>
        </a:graphic>
      </p:graphicFrame>
      <p:graphicFrame>
        <p:nvGraphicFramePr>
          <p:cNvPr id="50" name="Table 3">
            <a:extLst>
              <a:ext uri="{FF2B5EF4-FFF2-40B4-BE49-F238E27FC236}">
                <a16:creationId xmlns:a16="http://schemas.microsoft.com/office/drawing/2014/main" id="{2E9DCA58-F1AD-3E49-BBC7-BE0B77271D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2778475"/>
              </p:ext>
            </p:extLst>
          </p:nvPr>
        </p:nvGraphicFramePr>
        <p:xfrm>
          <a:off x="4559620" y="7779327"/>
          <a:ext cx="1008000" cy="640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04000">
                  <a:extLst>
                    <a:ext uri="{9D8B030D-6E8A-4147-A177-3AD203B41FA5}">
                      <a16:colId xmlns:a16="http://schemas.microsoft.com/office/drawing/2014/main" val="662194606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56224758"/>
                    </a:ext>
                  </a:extLst>
                </a:gridCol>
              </a:tblGrid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5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6442337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83699311"/>
                  </a:ext>
                </a:extLst>
              </a:tr>
              <a:tr h="124682">
                <a:tc gridSpan="2">
                  <a:txBody>
                    <a:bodyPr/>
                    <a:lstStyle/>
                    <a:p>
                      <a:pPr algn="ctr"/>
                      <a:r>
                        <a:rPr lang="en-K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4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KR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6997690"/>
                  </a:ext>
                </a:extLst>
              </a:tr>
            </a:tbl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F2D2F0A9-B7ED-1D45-9526-FB2C989DF559}"/>
              </a:ext>
            </a:extLst>
          </p:cNvPr>
          <p:cNvSpPr txBox="1"/>
          <p:nvPr/>
        </p:nvSpPr>
        <p:spPr>
          <a:xfrm>
            <a:off x="754891" y="5538295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55B625-E69B-A545-95F2-76961700B464}"/>
              </a:ext>
            </a:extLst>
          </p:cNvPr>
          <p:cNvSpPr txBox="1"/>
          <p:nvPr/>
        </p:nvSpPr>
        <p:spPr>
          <a:xfrm>
            <a:off x="385983" y="193971"/>
            <a:ext cx="564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Clinical relations of somatic alterations detected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fDN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rom lung and colorectal cancer patients.</a:t>
            </a:r>
            <a:r>
              <a:rPr lang="en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2184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4C5D3D1B-7E79-1F49-990E-A71DE135294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601" t="12550" b="26360"/>
          <a:stretch/>
        </p:blipFill>
        <p:spPr>
          <a:xfrm>
            <a:off x="3132761" y="870023"/>
            <a:ext cx="2651888" cy="1938992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5DEC170F-B773-E946-820E-5526B971E9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601" t="12550" b="26360"/>
          <a:stretch/>
        </p:blipFill>
        <p:spPr>
          <a:xfrm>
            <a:off x="442590" y="870024"/>
            <a:ext cx="2651888" cy="1938992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6B359320-5F98-E444-A7C2-2101D6FB8B57}"/>
              </a:ext>
            </a:extLst>
          </p:cNvPr>
          <p:cNvSpPr txBox="1"/>
          <p:nvPr/>
        </p:nvSpPr>
        <p:spPr>
          <a:xfrm>
            <a:off x="82169" y="37062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6CB0B01-7856-6C45-AC8A-79E594716EA0}"/>
              </a:ext>
            </a:extLst>
          </p:cNvPr>
          <p:cNvSpPr txBox="1"/>
          <p:nvPr/>
        </p:nvSpPr>
        <p:spPr>
          <a:xfrm>
            <a:off x="646187" y="598069"/>
            <a:ext cx="24224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Lung cancer (n = 18, median = 6.65 ng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562819-0EDA-3F48-9FFE-6BE9226CD489}"/>
              </a:ext>
            </a:extLst>
          </p:cNvPr>
          <p:cNvSpPr txBox="1"/>
          <p:nvPr/>
        </p:nvSpPr>
        <p:spPr>
          <a:xfrm>
            <a:off x="3259985" y="598069"/>
            <a:ext cx="2473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Colon cancer (n = 37, median = 8.88 ng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D1D66F-DCE5-4047-AE38-6942C6FB14EA}"/>
              </a:ext>
            </a:extLst>
          </p:cNvPr>
          <p:cNvSpPr txBox="1"/>
          <p:nvPr/>
        </p:nvSpPr>
        <p:spPr>
          <a:xfrm rot="16200000">
            <a:off x="-235216" y="1584344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Survival probability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D3ADC553-E097-F84A-83AA-6972D8AF3E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9771" t="2661" r="24644" b="89877"/>
          <a:stretch/>
        </p:blipFill>
        <p:spPr>
          <a:xfrm>
            <a:off x="5849115" y="1812158"/>
            <a:ext cx="218349" cy="246221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583A88D-F4B9-D645-AF25-AA8663BEE05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921" t="2661" r="57493" b="89877"/>
          <a:stretch/>
        </p:blipFill>
        <p:spPr>
          <a:xfrm>
            <a:off x="5849115" y="1593299"/>
            <a:ext cx="218349" cy="24622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0316B04-617F-2C49-97EB-EE1659377723}"/>
              </a:ext>
            </a:extLst>
          </p:cNvPr>
          <p:cNvSpPr txBox="1"/>
          <p:nvPr/>
        </p:nvSpPr>
        <p:spPr>
          <a:xfrm>
            <a:off x="6016331" y="1584008"/>
            <a:ext cx="713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&gt; media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6FE7AC6-E9C4-134B-9E3C-118A45958293}"/>
              </a:ext>
            </a:extLst>
          </p:cNvPr>
          <p:cNvSpPr txBox="1"/>
          <p:nvPr/>
        </p:nvSpPr>
        <p:spPr>
          <a:xfrm>
            <a:off x="6016331" y="1801514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≤ median</a:t>
            </a:r>
          </a:p>
        </p:txBody>
      </p:sp>
    </p:spTree>
    <p:extLst>
      <p:ext uri="{BB962C8B-B14F-4D97-AF65-F5344CB8AC3E}">
        <p14:creationId xmlns:p14="http://schemas.microsoft.com/office/powerpoint/2010/main" val="640257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988C112-9A0E-A946-9054-7B5414D16C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9179" y="1954239"/>
            <a:ext cx="1314450" cy="14859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DC4E344-051F-E548-B23F-E1A2C48CB3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179" y="3117308"/>
            <a:ext cx="1314450" cy="14859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29AB29C-7742-314A-A795-4AA847CC58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8746" y="1954239"/>
            <a:ext cx="1314450" cy="14859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00EFAFC-458E-8C4D-880A-CF1BB6AB7A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9967" y="3117308"/>
            <a:ext cx="1314450" cy="14859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98765F6-0432-7B47-88EF-BF57803315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8313" y="1954239"/>
            <a:ext cx="1314450" cy="14859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653217B-6285-CA45-844E-261F4FED48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47881" y="1954239"/>
            <a:ext cx="1314450" cy="14859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6DFD3E9-0F7D-9C4C-81E7-D86E811FAEA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1543" y="3117308"/>
            <a:ext cx="1314450" cy="14859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C7B78CE-31D5-C74B-ADF1-29AB3EB6FA2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40768" r="13297" b="36070"/>
          <a:stretch/>
        </p:blipFill>
        <p:spPr>
          <a:xfrm>
            <a:off x="621035" y="942726"/>
            <a:ext cx="1458999" cy="40005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D657E28-3AB4-8B41-AFFD-75F29C58842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40773" r="13297" b="36066"/>
          <a:stretch/>
        </p:blipFill>
        <p:spPr>
          <a:xfrm>
            <a:off x="621035" y="1480634"/>
            <a:ext cx="1458999" cy="40003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87BAC1C-B520-5D44-A05B-5B9D2EA9962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40768" r="13297" b="36070"/>
          <a:stretch/>
        </p:blipFill>
        <p:spPr>
          <a:xfrm>
            <a:off x="2080034" y="942726"/>
            <a:ext cx="1458999" cy="40005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08FCAD9-FE8B-B04D-9893-7AEAFB23065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40773" r="13297" b="36066"/>
          <a:stretch/>
        </p:blipFill>
        <p:spPr>
          <a:xfrm>
            <a:off x="2080034" y="1480634"/>
            <a:ext cx="1458999" cy="40003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A43BF230-C5F1-BD4F-A18B-62B61519268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40768" r="13297" b="36070"/>
          <a:stretch/>
        </p:blipFill>
        <p:spPr>
          <a:xfrm>
            <a:off x="3539033" y="942726"/>
            <a:ext cx="1458999" cy="400054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D61C3D3-E5E5-A948-80AF-81DD29697DFD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0773" r="13297" b="36066"/>
          <a:stretch/>
        </p:blipFill>
        <p:spPr>
          <a:xfrm>
            <a:off x="3539033" y="1480634"/>
            <a:ext cx="1458999" cy="40003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8799937C-779A-0C48-B2D1-CE366A60A8CB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40768" b="36070"/>
          <a:stretch/>
        </p:blipFill>
        <p:spPr>
          <a:xfrm>
            <a:off x="4998032" y="942726"/>
            <a:ext cx="1682750" cy="400054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C3B5E213-4F62-8A4E-AFC3-37B104893CD4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40773" b="36066"/>
          <a:stretch/>
        </p:blipFill>
        <p:spPr>
          <a:xfrm>
            <a:off x="4998032" y="1480634"/>
            <a:ext cx="1682750" cy="400037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30A272B4-36EC-4745-9B6C-C8C2CB5747F1}"/>
              </a:ext>
            </a:extLst>
          </p:cNvPr>
          <p:cNvSpPr txBox="1"/>
          <p:nvPr/>
        </p:nvSpPr>
        <p:spPr>
          <a:xfrm>
            <a:off x="1045162" y="661440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Lung_Cy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112A83E-BAF4-464C-B707-DF4B5B429EE1}"/>
              </a:ext>
            </a:extLst>
          </p:cNvPr>
          <p:cNvSpPr txBox="1"/>
          <p:nvPr/>
        </p:nvSpPr>
        <p:spPr>
          <a:xfrm>
            <a:off x="2441483" y="659721"/>
            <a:ext cx="7360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Lung_TK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4C4A485-8E35-884B-A076-23EEF4EFC598}"/>
              </a:ext>
            </a:extLst>
          </p:cNvPr>
          <p:cNvSpPr txBox="1"/>
          <p:nvPr/>
        </p:nvSpPr>
        <p:spPr>
          <a:xfrm>
            <a:off x="3933327" y="660580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Colon_Cy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B32550-6272-1344-A51F-1D6CCB334722}"/>
              </a:ext>
            </a:extLst>
          </p:cNvPr>
          <p:cNvSpPr txBox="1"/>
          <p:nvPr/>
        </p:nvSpPr>
        <p:spPr>
          <a:xfrm>
            <a:off x="5329648" y="658861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Colon_Cetx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140AEC5-229E-3249-9E46-EBBCA3CBF731}"/>
              </a:ext>
            </a:extLst>
          </p:cNvPr>
          <p:cNvSpPr txBox="1"/>
          <p:nvPr/>
        </p:nvSpPr>
        <p:spPr>
          <a:xfrm>
            <a:off x="173045" y="101833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Bas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E5D9E9D-D746-A340-8C5E-397D0A4466D8}"/>
              </a:ext>
            </a:extLst>
          </p:cNvPr>
          <p:cNvSpPr txBox="1"/>
          <p:nvPr/>
        </p:nvSpPr>
        <p:spPr>
          <a:xfrm>
            <a:off x="213440" y="1548124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Res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A5D39F29-4FED-1743-9819-540197C4D12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273751" y="5507505"/>
            <a:ext cx="4447459" cy="1803932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AF39ECFA-5763-B544-97C3-B362DD553A3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8854" y="5507505"/>
            <a:ext cx="2120579" cy="1803932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839AD1C4-3FB1-984C-BC19-C13BE479E26B}"/>
              </a:ext>
            </a:extLst>
          </p:cNvPr>
          <p:cNvGrpSpPr/>
          <p:nvPr/>
        </p:nvGrpSpPr>
        <p:grpSpPr>
          <a:xfrm>
            <a:off x="3340755" y="3117308"/>
            <a:ext cx="1425076" cy="1485900"/>
            <a:chOff x="3340755" y="2844176"/>
            <a:chExt cx="1425076" cy="148590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4FE7DFED-051F-494C-A4C5-12DD71E961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340755" y="2844176"/>
              <a:ext cx="1314450" cy="14859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32513B9-02DD-6143-9D3C-C494C5553362}"/>
                </a:ext>
              </a:extLst>
            </p:cNvPr>
            <p:cNvSpPr txBox="1"/>
            <p:nvPr/>
          </p:nvSpPr>
          <p:spPr>
            <a:xfrm>
              <a:off x="4523457" y="3582487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KR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0AB8FC31-6D27-8D40-82A5-524C63736BE3}"/>
              </a:ext>
            </a:extLst>
          </p:cNvPr>
          <p:cNvSpPr txBox="1"/>
          <p:nvPr/>
        </p:nvSpPr>
        <p:spPr>
          <a:xfrm>
            <a:off x="82169" y="643761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140F053-D462-4D47-8E26-2DC1C81DB222}"/>
              </a:ext>
            </a:extLst>
          </p:cNvPr>
          <p:cNvSpPr txBox="1"/>
          <p:nvPr/>
        </p:nvSpPr>
        <p:spPr>
          <a:xfrm>
            <a:off x="141432" y="5213903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2FCE11E-DAC4-3049-B271-89DA19C76BBF}"/>
              </a:ext>
            </a:extLst>
          </p:cNvPr>
          <p:cNvSpPr txBox="1"/>
          <p:nvPr/>
        </p:nvSpPr>
        <p:spPr>
          <a:xfrm>
            <a:off x="716553" y="5300294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Lung cance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04D3C0D-58C6-2A4A-AF31-3B3576A56BAF}"/>
              </a:ext>
            </a:extLst>
          </p:cNvPr>
          <p:cNvSpPr txBox="1"/>
          <p:nvPr/>
        </p:nvSpPr>
        <p:spPr>
          <a:xfrm>
            <a:off x="3881228" y="5302534"/>
            <a:ext cx="1178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000" dirty="0">
                <a:latin typeface="Arial" panose="020B0604020202020204" pitchFamily="34" charset="0"/>
                <a:cs typeface="Arial" panose="020B0604020202020204" pitchFamily="34" charset="0"/>
              </a:rPr>
              <a:t>Colorectal cancer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C28782C-2C53-384E-869E-A874382D4495}"/>
              </a:ext>
            </a:extLst>
          </p:cNvPr>
          <p:cNvSpPr txBox="1"/>
          <p:nvPr/>
        </p:nvSpPr>
        <p:spPr>
          <a:xfrm>
            <a:off x="176975" y="150680"/>
            <a:ext cx="5216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Characteristic of potential somatic SNVs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989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46B3F67F-1550-7641-B5CA-3397345DA0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2590" y="3603306"/>
            <a:ext cx="2989580" cy="2652294"/>
          </a:xfrm>
          <a:prstGeom prst="rect">
            <a:avLst/>
          </a:prstGeom>
        </p:spPr>
      </p:pic>
      <p:graphicFrame>
        <p:nvGraphicFramePr>
          <p:cNvPr id="42" name="표 7">
            <a:extLst>
              <a:ext uri="{FF2B5EF4-FFF2-40B4-BE49-F238E27FC236}">
                <a16:creationId xmlns:a16="http://schemas.microsoft.com/office/drawing/2014/main" id="{61265ABF-14EC-6D4B-9A48-8E5E6C2974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9328132"/>
              </p:ext>
            </p:extLst>
          </p:nvPr>
        </p:nvGraphicFramePr>
        <p:xfrm>
          <a:off x="608999" y="800695"/>
          <a:ext cx="5640002" cy="228428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val="1798532281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3486595616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74491842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1641031984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3262774801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765306233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71216643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881408692"/>
                    </a:ext>
                  </a:extLst>
                </a:gridCol>
                <a:gridCol w="528002">
                  <a:extLst>
                    <a:ext uri="{9D8B030D-6E8A-4147-A177-3AD203B41FA5}">
                      <a16:colId xmlns:a16="http://schemas.microsoft.com/office/drawing/2014/main" val="4164042307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1549757200"/>
                    </a:ext>
                  </a:extLst>
                </a:gridCol>
              </a:tblGrid>
              <a:tr h="101059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2" gridSpan="5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d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</a:t>
                      </a:r>
                      <a:endParaRPr lang="en-US" altLang="ko-KR" sz="800" b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extLst>
                  <a:ext uri="{0D108BD9-81ED-4DB2-BD59-A6C34878D82A}">
                    <a16:rowId xmlns:a16="http://schemas.microsoft.com/office/drawing/2014/main" val="1803861302"/>
                  </a:ext>
                </a:extLst>
              </a:tr>
              <a:tr h="609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5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ads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llelic fraction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ads</a:t>
                      </a:r>
                    </a:p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ref, alt)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6881345"/>
                  </a:ext>
                </a:extLst>
              </a:tr>
              <a:tr h="96149">
                <a:tc vMerge="1">
                  <a:txBody>
                    <a:bodyPr/>
                    <a:lstStyle/>
                    <a:p>
                      <a:endParaRPr lang="en-K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K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DNA</a:t>
                      </a:r>
                    </a:p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g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pted</a:t>
                      </a:r>
                    </a:p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plet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ctional</a:t>
                      </a:r>
                    </a:p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undance (%)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 vMerge="1">
                  <a:txBody>
                    <a:bodyPr/>
                    <a:lstStyle/>
                    <a:p>
                      <a:endParaRPr lang="en-K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K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K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4387516"/>
                  </a:ext>
                </a:extLst>
              </a:tr>
              <a:tr h="101059"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 G12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P025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9741641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P025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1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859266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P054Base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48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072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7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5754778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P054Res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28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098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.7</a:t>
                      </a: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.7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KR" sz="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4, 17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072869"/>
                  </a:ext>
                </a:extLst>
              </a:tr>
              <a:tr h="10105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 G12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356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6, 18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3752522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356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0.4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, 6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062100"/>
                  </a:ext>
                </a:extLst>
              </a:tr>
              <a:tr h="10105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 G12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271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1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, 2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1486493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271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.3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2, 6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828487"/>
                  </a:ext>
                </a:extLst>
              </a:tr>
              <a:tr h="1010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 G13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295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4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1886550"/>
                  </a:ext>
                </a:extLst>
              </a:tr>
              <a:tr h="1010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AS Q61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S240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5456819"/>
                  </a:ext>
                </a:extLst>
              </a:tr>
              <a:tr h="1010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 Ex19 de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LCP298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.3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39, 14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6367353"/>
                  </a:ext>
                </a:extLst>
              </a:tr>
              <a:tr h="1010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 L858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LCP349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4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2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, 19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5152444"/>
                  </a:ext>
                </a:extLst>
              </a:tr>
              <a:tr h="10105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F V600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289Bas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3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7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0.8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6, 34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7587415"/>
                  </a:ext>
                </a:extLst>
              </a:tr>
              <a:tr h="101059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CP247Re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0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ko-K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418" marR="9418" marT="9418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593501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75955CF-D02B-CA4F-861D-9798790DD820}"/>
              </a:ext>
            </a:extLst>
          </p:cNvPr>
          <p:cNvSpPr txBox="1"/>
          <p:nvPr/>
        </p:nvSpPr>
        <p:spPr>
          <a:xfrm>
            <a:off x="244020" y="735217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DED2BB-ACFC-944F-A886-EB4156099001}"/>
              </a:ext>
            </a:extLst>
          </p:cNvPr>
          <p:cNvSpPr txBox="1"/>
          <p:nvPr/>
        </p:nvSpPr>
        <p:spPr>
          <a:xfrm>
            <a:off x="1701577" y="3434029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R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74FE20-D087-0942-90CE-E7B3DC3A7B1A}"/>
              </a:ext>
            </a:extLst>
          </p:cNvPr>
          <p:cNvSpPr txBox="1"/>
          <p:nvPr/>
        </p:nvSpPr>
        <p:spPr>
          <a:xfrm>
            <a:off x="311559" y="150991"/>
            <a:ext cx="57862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Comparing mutation allelic fraction quantified from serum by WES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327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043</TotalTime>
  <Words>342</Words>
  <Application>Microsoft Macintosh PowerPoint</Application>
  <PresentationFormat>A4 Paper (210x297 mm)</PresentationFormat>
  <Paragraphs>19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L</dc:creator>
  <cp:lastModifiedBy>JL</cp:lastModifiedBy>
  <cp:revision>70</cp:revision>
  <cp:lastPrinted>2021-11-22T04:56:25Z</cp:lastPrinted>
  <dcterms:created xsi:type="dcterms:W3CDTF">2021-08-01T04:14:35Z</dcterms:created>
  <dcterms:modified xsi:type="dcterms:W3CDTF">2022-01-31T07:12:56Z</dcterms:modified>
</cp:coreProperties>
</file>